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E80339-B62E-40A5-AF31-D026F2EB430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E5A8B2-FA7D-4AC8-9698-32066643F4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F6A53D-7FE6-4A92-B9AA-1036D26EB44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4AB854-597F-4EB6-860A-3929F464E76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7DFDDF-706A-4068-9965-AB4D95DD76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7E8C56-6E85-49EA-9B05-15F55270DD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558887-231B-4C7D-92BA-77D1377B71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B4B526-32C0-4832-B95A-5CBA9A695A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441EF9-8808-43F1-8453-222541CCF5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E46D62-4BC4-4311-9413-6BF432D6F5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F0A168-BE84-4E8F-ABE7-94F28BEFB5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E6CDF1-C79A-4AF1-8242-CC3F8DFDC9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3C14FF9-5245-4FEE-B6AC-A7490FA91F5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5"/>
          <p:cNvSpPr/>
          <p:nvPr/>
        </p:nvSpPr>
        <p:spPr>
          <a:xfrm>
            <a:off x="34200" y="7632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6"/>
          <p:cNvSpPr/>
          <p:nvPr/>
        </p:nvSpPr>
        <p:spPr>
          <a:xfrm>
            <a:off x="204480" y="3008160"/>
            <a:ext cx="651600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lymerase theta orthologues from various metazoans.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he conserved helicase-like (blue oval) and polymerase (pink box) domains ar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ndicated.  All of the orthologs have additional conserved regions in the N- an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-termini (white boxes), separated by a variable-length linker region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Object 7"/>
          <p:cNvGraphicFramePr/>
          <p:nvPr/>
        </p:nvGraphicFramePr>
        <p:xfrm>
          <a:off x="533520" y="685800"/>
          <a:ext cx="5776920" cy="20574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4" name="Object 7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33520" y="685800"/>
                    <a:ext cx="5776920" cy="2057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4T05:34:06Z</dcterms:created>
  <dc:creator>Mitch McVey</dc:creator>
  <dc:description/>
  <dc:language>en-US</dc:language>
  <cp:lastModifiedBy>Mitch McVey</cp:lastModifiedBy>
  <dcterms:modified xsi:type="dcterms:W3CDTF">2010-05-09T18:27:44Z</dcterms:modified>
  <cp:revision>3</cp:revision>
  <dc:subject/>
  <dc:title>Slide 1</dc:title>
</cp:coreProperties>
</file>